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4" d="100"/>
          <a:sy n="154" d="100"/>
        </p:scale>
        <p:origin x="-231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Объект 2">
            <a:extLst>
              <a:ext uri="{FF2B5EF4-FFF2-40B4-BE49-F238E27FC236}">
                <a16:creationId xmlns="" xmlns:a16="http://schemas.microsoft.com/office/drawing/2014/main" id="{B5A1926C-F1CF-5BDA-0061-F4962B0CECDA}"/>
              </a:ext>
            </a:extLst>
          </p:cNvPr>
          <p:cNvSpPr txBox="1">
            <a:spLocks/>
          </p:cNvSpPr>
          <p:nvPr/>
        </p:nvSpPr>
        <p:spPr>
          <a:xfrm>
            <a:off x="155448" y="5943600"/>
            <a:ext cx="8862822" cy="5760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erarchical cluster analysis of DEGs in IR-s vs. SO-s and IR-f vs.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-f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Each row represents a DEG; n = 3 per group. Only those genes with cut-off &gt;1.5 and </a:t>
            </a:r>
            <a:r>
              <a:rPr lang="en-US" sz="14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</a:t>
            </a:r>
            <a:endParaRPr lang="ru-RU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Прямоугольник 8"/>
          <p:cNvSpPr/>
          <p:nvPr/>
        </p:nvSpPr>
        <p:spPr>
          <a:xfrm>
            <a:off x="169865" y="76200"/>
            <a:ext cx="874553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fferential expressed genes </a:t>
            </a:r>
            <a:r>
              <a:rPr lang="en-US" sz="14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that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howed </a:t>
            </a:r>
            <a:r>
              <a:rPr lang="en-US" sz="14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opposite-directed changes in expression in </a:t>
            </a:r>
            <a:r>
              <a:rPr lang="en-GB" sz="14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C and striatum under IR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 after </a:t>
            </a:r>
            <a:r>
              <a:rPr lang="en-GB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1026" name="Picture 2" descr="K:\Редактируемые\Для публикаций\0_текущие публикации\ишемия_2\стриатум 24h\статья по 24 часам striat\1_IR Str-FC\fs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6173" y="761999"/>
            <a:ext cx="2792412" cy="49498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22790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69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3</cp:revision>
  <dcterms:created xsi:type="dcterms:W3CDTF">2006-08-16T00:00:00Z</dcterms:created>
  <dcterms:modified xsi:type="dcterms:W3CDTF">2025-01-16T12:21:36Z</dcterms:modified>
</cp:coreProperties>
</file>